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6" r:id="rId3"/>
    <p:sldId id="257" r:id="rId4"/>
    <p:sldId id="267" r:id="rId5"/>
    <p:sldId id="269" r:id="rId6"/>
    <p:sldId id="265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BE697-F39C-4C79-A142-2B990A14CA0C}" type="datetimeFigureOut">
              <a:rPr lang="en-US" smtClean="0"/>
              <a:t>2023-02-0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EB6A7-F0D6-47B8-AE88-437C26F52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27287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BE697-F39C-4C79-A142-2B990A14CA0C}" type="datetimeFigureOut">
              <a:rPr lang="en-US" smtClean="0"/>
              <a:t>2023-02-0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EB6A7-F0D6-47B8-AE88-437C26F52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1636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BE697-F39C-4C79-A142-2B990A14CA0C}" type="datetimeFigureOut">
              <a:rPr lang="en-US" smtClean="0"/>
              <a:t>2023-02-0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EB6A7-F0D6-47B8-AE88-437C26F52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88865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BE697-F39C-4C79-A142-2B990A14CA0C}" type="datetimeFigureOut">
              <a:rPr lang="en-US" smtClean="0"/>
              <a:t>2023-02-0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EB6A7-F0D6-47B8-AE88-437C26F52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088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BE697-F39C-4C79-A142-2B990A14CA0C}" type="datetimeFigureOut">
              <a:rPr lang="en-US" smtClean="0"/>
              <a:t>2023-02-0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EB6A7-F0D6-47B8-AE88-437C26F52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92919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BE697-F39C-4C79-A142-2B990A14CA0C}" type="datetimeFigureOut">
              <a:rPr lang="en-US" smtClean="0"/>
              <a:t>2023-02-0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EB6A7-F0D6-47B8-AE88-437C26F52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4582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BE697-F39C-4C79-A142-2B990A14CA0C}" type="datetimeFigureOut">
              <a:rPr lang="en-US" smtClean="0"/>
              <a:t>2023-02-0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EB6A7-F0D6-47B8-AE88-437C26F52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561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BE697-F39C-4C79-A142-2B990A14CA0C}" type="datetimeFigureOut">
              <a:rPr lang="en-US" smtClean="0"/>
              <a:t>2023-02-0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EB6A7-F0D6-47B8-AE88-437C26F52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8031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BE697-F39C-4C79-A142-2B990A14CA0C}" type="datetimeFigureOut">
              <a:rPr lang="en-US" smtClean="0"/>
              <a:t>2023-02-0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EB6A7-F0D6-47B8-AE88-437C26F52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8568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BE697-F39C-4C79-A142-2B990A14CA0C}" type="datetimeFigureOut">
              <a:rPr lang="en-US" smtClean="0"/>
              <a:t>2023-02-0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EB6A7-F0D6-47B8-AE88-437C26F52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2450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7BE697-F39C-4C79-A142-2B990A14CA0C}" type="datetimeFigureOut">
              <a:rPr lang="en-US" smtClean="0"/>
              <a:t>2023-02-0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CEB6A7-F0D6-47B8-AE88-437C26F52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4909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7BE697-F39C-4C79-A142-2B990A14CA0C}" type="datetimeFigureOut">
              <a:rPr lang="en-US" smtClean="0"/>
              <a:t>2023-02-0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CEB6A7-F0D6-47B8-AE88-437C26F52F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51550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3EF7909-A77B-62F4-8A33-129D791EC88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75799319"/>
              </p:ext>
            </p:extLst>
          </p:nvPr>
        </p:nvGraphicFramePr>
        <p:xfrm>
          <a:off x="419448" y="1819442"/>
          <a:ext cx="11073468" cy="200656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969471">
                  <a:extLst>
                    <a:ext uri="{9D8B030D-6E8A-4147-A177-3AD203B41FA5}">
                      <a16:colId xmlns:a16="http://schemas.microsoft.com/office/drawing/2014/main" val="1175527465"/>
                    </a:ext>
                  </a:extLst>
                </a:gridCol>
                <a:gridCol w="1056945">
                  <a:extLst>
                    <a:ext uri="{9D8B030D-6E8A-4147-A177-3AD203B41FA5}">
                      <a16:colId xmlns:a16="http://schemas.microsoft.com/office/drawing/2014/main" val="510652459"/>
                    </a:ext>
                  </a:extLst>
                </a:gridCol>
                <a:gridCol w="615445">
                  <a:extLst>
                    <a:ext uri="{9D8B030D-6E8A-4147-A177-3AD203B41FA5}">
                      <a16:colId xmlns:a16="http://schemas.microsoft.com/office/drawing/2014/main" val="3224859168"/>
                    </a:ext>
                  </a:extLst>
                </a:gridCol>
                <a:gridCol w="676991">
                  <a:extLst>
                    <a:ext uri="{9D8B030D-6E8A-4147-A177-3AD203B41FA5}">
                      <a16:colId xmlns:a16="http://schemas.microsoft.com/office/drawing/2014/main" val="4035048565"/>
                    </a:ext>
                  </a:extLst>
                </a:gridCol>
                <a:gridCol w="676991">
                  <a:extLst>
                    <a:ext uri="{9D8B030D-6E8A-4147-A177-3AD203B41FA5}">
                      <a16:colId xmlns:a16="http://schemas.microsoft.com/office/drawing/2014/main" val="1154577809"/>
                    </a:ext>
                  </a:extLst>
                </a:gridCol>
                <a:gridCol w="676991">
                  <a:extLst>
                    <a:ext uri="{9D8B030D-6E8A-4147-A177-3AD203B41FA5}">
                      <a16:colId xmlns:a16="http://schemas.microsoft.com/office/drawing/2014/main" val="2783701366"/>
                    </a:ext>
                  </a:extLst>
                </a:gridCol>
                <a:gridCol w="676991">
                  <a:extLst>
                    <a:ext uri="{9D8B030D-6E8A-4147-A177-3AD203B41FA5}">
                      <a16:colId xmlns:a16="http://schemas.microsoft.com/office/drawing/2014/main" val="1676190469"/>
                    </a:ext>
                  </a:extLst>
                </a:gridCol>
                <a:gridCol w="615445">
                  <a:extLst>
                    <a:ext uri="{9D8B030D-6E8A-4147-A177-3AD203B41FA5}">
                      <a16:colId xmlns:a16="http://schemas.microsoft.com/office/drawing/2014/main" val="2254361187"/>
                    </a:ext>
                  </a:extLst>
                </a:gridCol>
                <a:gridCol w="615445">
                  <a:extLst>
                    <a:ext uri="{9D8B030D-6E8A-4147-A177-3AD203B41FA5}">
                      <a16:colId xmlns:a16="http://schemas.microsoft.com/office/drawing/2014/main" val="8808147"/>
                    </a:ext>
                  </a:extLst>
                </a:gridCol>
                <a:gridCol w="615445">
                  <a:extLst>
                    <a:ext uri="{9D8B030D-6E8A-4147-A177-3AD203B41FA5}">
                      <a16:colId xmlns:a16="http://schemas.microsoft.com/office/drawing/2014/main" val="3999494950"/>
                    </a:ext>
                  </a:extLst>
                </a:gridCol>
                <a:gridCol w="676991">
                  <a:extLst>
                    <a:ext uri="{9D8B030D-6E8A-4147-A177-3AD203B41FA5}">
                      <a16:colId xmlns:a16="http://schemas.microsoft.com/office/drawing/2014/main" val="1674793405"/>
                    </a:ext>
                  </a:extLst>
                </a:gridCol>
                <a:gridCol w="676991">
                  <a:extLst>
                    <a:ext uri="{9D8B030D-6E8A-4147-A177-3AD203B41FA5}">
                      <a16:colId xmlns:a16="http://schemas.microsoft.com/office/drawing/2014/main" val="142641283"/>
                    </a:ext>
                  </a:extLst>
                </a:gridCol>
                <a:gridCol w="676991">
                  <a:extLst>
                    <a:ext uri="{9D8B030D-6E8A-4147-A177-3AD203B41FA5}">
                      <a16:colId xmlns:a16="http://schemas.microsoft.com/office/drawing/2014/main" val="1444324271"/>
                    </a:ext>
                  </a:extLst>
                </a:gridCol>
                <a:gridCol w="615445">
                  <a:extLst>
                    <a:ext uri="{9D8B030D-6E8A-4147-A177-3AD203B41FA5}">
                      <a16:colId xmlns:a16="http://schemas.microsoft.com/office/drawing/2014/main" val="1894077086"/>
                    </a:ext>
                  </a:extLst>
                </a:gridCol>
                <a:gridCol w="615445">
                  <a:extLst>
                    <a:ext uri="{9D8B030D-6E8A-4147-A177-3AD203B41FA5}">
                      <a16:colId xmlns:a16="http://schemas.microsoft.com/office/drawing/2014/main" val="1884508021"/>
                    </a:ext>
                  </a:extLst>
                </a:gridCol>
                <a:gridCol w="615445">
                  <a:extLst>
                    <a:ext uri="{9D8B030D-6E8A-4147-A177-3AD203B41FA5}">
                      <a16:colId xmlns:a16="http://schemas.microsoft.com/office/drawing/2014/main" val="1952315026"/>
                    </a:ext>
                  </a:extLst>
                </a:gridCol>
              </a:tblGrid>
              <a:tr h="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 dirty="0">
                          <a:effectLst/>
                        </a:rPr>
                        <a:t>Pig #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 dirty="0">
                          <a:effectLst/>
                        </a:rPr>
                        <a:t> Group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 gridSpan="14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 dirty="0">
                          <a:effectLst/>
                        </a:rPr>
                        <a:t>Body temperature (°C) - Days post-infection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48548186"/>
                  </a:ext>
                </a:extLst>
              </a:tr>
              <a:tr h="11469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050" dirty="0">
                          <a:effectLst/>
                        </a:rPr>
                        <a:t> </a:t>
                      </a:r>
                      <a:endParaRPr lang="en-US" sz="105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0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4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5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6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7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15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2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26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28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29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0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2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3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extLst>
                  <a:ext uri="{0D108BD9-81ED-4DB2-BD59-A6C34878D82A}">
                    <a16:rowId xmlns:a16="http://schemas.microsoft.com/office/drawing/2014/main" val="917276203"/>
                  </a:ext>
                </a:extLst>
              </a:tr>
              <a:tr h="22838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2303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 dirty="0">
                          <a:effectLst/>
                        </a:rPr>
                        <a:t> PRV wild-type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9.39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40.78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 dirty="0">
                          <a:effectLst/>
                        </a:rPr>
                        <a:t>41.61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40.89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9.56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6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9.06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6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56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6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39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7.78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43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7.89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extLst>
                  <a:ext uri="{0D108BD9-81ED-4DB2-BD59-A6C34878D82A}">
                    <a16:rowId xmlns:a16="http://schemas.microsoft.com/office/drawing/2014/main" val="864701989"/>
                  </a:ext>
                </a:extLst>
              </a:tr>
              <a:tr h="22838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2306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9.33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40.39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40.6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40.78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9.67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9.6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89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7.78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83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7.67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17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33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66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6.89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extLst>
                  <a:ext uri="{0D108BD9-81ED-4DB2-BD59-A6C34878D82A}">
                    <a16:rowId xmlns:a16="http://schemas.microsoft.com/office/drawing/2014/main" val="3846427824"/>
                  </a:ext>
                </a:extLst>
              </a:tr>
              <a:tr h="22838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2309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 row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 dirty="0">
                          <a:effectLst/>
                        </a:rPr>
                        <a:t> PRVtmv+</a:t>
                      </a: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9.5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83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9.0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8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63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9.44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9.33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9.6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9.44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33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9.2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6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7.28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9.03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extLst>
                  <a:ext uri="{0D108BD9-81ED-4DB2-BD59-A6C34878D82A}">
                    <a16:rowId xmlns:a16="http://schemas.microsoft.com/office/drawing/2014/main" val="2465854939"/>
                  </a:ext>
                </a:extLst>
              </a:tr>
              <a:tr h="22838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2312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700">
                          <a:effectLst/>
                        </a:rPr>
                        <a:t> </a:t>
                      </a:r>
                      <a:endParaRPr lang="en-US" sz="7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9.33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94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89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 dirty="0">
                          <a:effectLst/>
                        </a:rPr>
                        <a:t>38.86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84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89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72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56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9.1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44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76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39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17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66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extLst>
                  <a:ext uri="{0D108BD9-81ED-4DB2-BD59-A6C34878D82A}">
                    <a16:rowId xmlns:a16="http://schemas.microsoft.com/office/drawing/2014/main" val="1484367017"/>
                  </a:ext>
                </a:extLst>
              </a:tr>
              <a:tr h="22838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 dirty="0">
                          <a:effectLst/>
                        </a:rPr>
                        <a:t>2315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700" dirty="0">
                          <a:effectLst/>
                        </a:rPr>
                        <a:t> </a:t>
                      </a:r>
                      <a:endParaRPr lang="en-US" sz="7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9.06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78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1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77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9.2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94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72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79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83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67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61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8.67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>
                          <a:effectLst/>
                        </a:rPr>
                        <a:t>37.33</a:t>
                      </a:r>
                      <a:endParaRPr lang="en-US" sz="18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800" dirty="0">
                          <a:effectLst/>
                        </a:rPr>
                        <a:t>38.76</a:t>
                      </a:r>
                      <a:endParaRPr lang="en-US" sz="18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43463" marR="43463" marT="6037" marB="0" anchor="ctr"/>
                </a:tc>
                <a:extLst>
                  <a:ext uri="{0D108BD9-81ED-4DB2-BD59-A6C34878D82A}">
                    <a16:rowId xmlns:a16="http://schemas.microsoft.com/office/drawing/2014/main" val="1966801983"/>
                  </a:ext>
                </a:extLst>
              </a:tr>
            </a:tbl>
          </a:graphicData>
        </a:graphic>
      </p:graphicFrame>
      <p:sp>
        <p:nvSpPr>
          <p:cNvPr id="4" name="Rectangle 3">
            <a:extLst>
              <a:ext uri="{FF2B5EF4-FFF2-40B4-BE49-F238E27FC236}">
                <a16:creationId xmlns:a16="http://schemas.microsoft.com/office/drawing/2014/main" id="{E7BCB47C-35A8-7D8C-A831-6B70AE699BD5}"/>
              </a:ext>
            </a:extLst>
          </p:cNvPr>
          <p:cNvSpPr/>
          <p:nvPr/>
        </p:nvSpPr>
        <p:spPr>
          <a:xfrm>
            <a:off x="441917" y="1009420"/>
            <a:ext cx="1078361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b="1" dirty="0"/>
              <a:t>Supplementary Table S1.</a:t>
            </a:r>
            <a:r>
              <a:rPr lang="en-US" sz="2400" dirty="0"/>
              <a:t> </a:t>
            </a:r>
            <a:r>
              <a:rPr lang="en-US" altLang="en-US" sz="2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ody temperature (°C) in pigs following PRV infection and latency-reactivation.</a:t>
            </a:r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43380769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4B90957F-5FB5-606C-7D46-1F24E3D37552}"/>
              </a:ext>
            </a:extLst>
          </p:cNvPr>
          <p:cNvSpPr/>
          <p:nvPr/>
        </p:nvSpPr>
        <p:spPr>
          <a:xfrm>
            <a:off x="584530" y="1563094"/>
            <a:ext cx="1078361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b="1" dirty="0"/>
              <a:t>Supplementary Table S2.</a:t>
            </a:r>
            <a:r>
              <a:rPr lang="en-US" sz="2400" dirty="0"/>
              <a:t> </a:t>
            </a:r>
            <a:r>
              <a:rPr lang="en-US" altLang="en-US" sz="2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linical scores in pigs after infection.</a:t>
            </a:r>
            <a:endParaRPr lang="en-US" sz="2400" dirty="0"/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130DB10B-A082-2B78-656C-BBF5529E1A7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37922387"/>
              </p:ext>
            </p:extLst>
          </p:nvPr>
        </p:nvGraphicFramePr>
        <p:xfrm>
          <a:off x="651642" y="2068332"/>
          <a:ext cx="10878206" cy="2823784"/>
        </p:xfrm>
        <a:graphic>
          <a:graphicData uri="http://schemas.openxmlformats.org/drawingml/2006/table">
            <a:tbl>
              <a:tblPr firstRow="1" firstCol="1" bandRow="1">
                <a:tableStyleId>{93296810-A885-4BE3-A3E7-6D5BEEA58F35}</a:tableStyleId>
              </a:tblPr>
              <a:tblGrid>
                <a:gridCol w="782875">
                  <a:extLst>
                    <a:ext uri="{9D8B030D-6E8A-4147-A177-3AD203B41FA5}">
                      <a16:colId xmlns:a16="http://schemas.microsoft.com/office/drawing/2014/main" val="1375020973"/>
                    </a:ext>
                  </a:extLst>
                </a:gridCol>
                <a:gridCol w="1317072">
                  <a:extLst>
                    <a:ext uri="{9D8B030D-6E8A-4147-A177-3AD203B41FA5}">
                      <a16:colId xmlns:a16="http://schemas.microsoft.com/office/drawing/2014/main" val="414966778"/>
                    </a:ext>
                  </a:extLst>
                </a:gridCol>
                <a:gridCol w="1199626">
                  <a:extLst>
                    <a:ext uri="{9D8B030D-6E8A-4147-A177-3AD203B41FA5}">
                      <a16:colId xmlns:a16="http://schemas.microsoft.com/office/drawing/2014/main" val="808382255"/>
                    </a:ext>
                  </a:extLst>
                </a:gridCol>
                <a:gridCol w="872455">
                  <a:extLst>
                    <a:ext uri="{9D8B030D-6E8A-4147-A177-3AD203B41FA5}">
                      <a16:colId xmlns:a16="http://schemas.microsoft.com/office/drawing/2014/main" val="1033747988"/>
                    </a:ext>
                  </a:extLst>
                </a:gridCol>
                <a:gridCol w="1174458">
                  <a:extLst>
                    <a:ext uri="{9D8B030D-6E8A-4147-A177-3AD203B41FA5}">
                      <a16:colId xmlns:a16="http://schemas.microsoft.com/office/drawing/2014/main" val="470190741"/>
                    </a:ext>
                  </a:extLst>
                </a:gridCol>
                <a:gridCol w="1216404">
                  <a:extLst>
                    <a:ext uri="{9D8B030D-6E8A-4147-A177-3AD203B41FA5}">
                      <a16:colId xmlns:a16="http://schemas.microsoft.com/office/drawing/2014/main" val="3328326551"/>
                    </a:ext>
                  </a:extLst>
                </a:gridCol>
                <a:gridCol w="1174459">
                  <a:extLst>
                    <a:ext uri="{9D8B030D-6E8A-4147-A177-3AD203B41FA5}">
                      <a16:colId xmlns:a16="http://schemas.microsoft.com/office/drawing/2014/main" val="1166284"/>
                    </a:ext>
                  </a:extLst>
                </a:gridCol>
                <a:gridCol w="981512">
                  <a:extLst>
                    <a:ext uri="{9D8B030D-6E8A-4147-A177-3AD203B41FA5}">
                      <a16:colId xmlns:a16="http://schemas.microsoft.com/office/drawing/2014/main" val="166130216"/>
                    </a:ext>
                  </a:extLst>
                </a:gridCol>
                <a:gridCol w="989901">
                  <a:extLst>
                    <a:ext uri="{9D8B030D-6E8A-4147-A177-3AD203B41FA5}">
                      <a16:colId xmlns:a16="http://schemas.microsoft.com/office/drawing/2014/main" val="532834653"/>
                    </a:ext>
                  </a:extLst>
                </a:gridCol>
                <a:gridCol w="1169444">
                  <a:extLst>
                    <a:ext uri="{9D8B030D-6E8A-4147-A177-3AD203B41FA5}">
                      <a16:colId xmlns:a16="http://schemas.microsoft.com/office/drawing/2014/main" val="3908367721"/>
                    </a:ext>
                  </a:extLst>
                </a:gridCol>
              </a:tblGrid>
              <a:tr h="423545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S no.: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 Group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 Animal #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gridSpan="7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Clinical score (Day-post infection)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5743791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 kern="1200" dirty="0">
                          <a:effectLst/>
                        </a:rPr>
                        <a:t>Day 0</a:t>
                      </a:r>
                      <a:endParaRPr lang="en-US" sz="2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 kern="1200" dirty="0">
                          <a:effectLst/>
                        </a:rPr>
                        <a:t>Day 3</a:t>
                      </a:r>
                      <a:endParaRPr lang="en-US" sz="2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 kern="1200" dirty="0">
                          <a:effectLst/>
                        </a:rPr>
                        <a:t>Day 4</a:t>
                      </a:r>
                      <a:endParaRPr lang="en-US" sz="2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 kern="1200" dirty="0">
                          <a:effectLst/>
                        </a:rPr>
                        <a:t>Day 5</a:t>
                      </a:r>
                      <a:endParaRPr lang="en-US" sz="2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 kern="1200" dirty="0">
                          <a:effectLst/>
                        </a:rPr>
                        <a:t>Day 6</a:t>
                      </a:r>
                      <a:endParaRPr lang="en-US" sz="2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 kern="1200" dirty="0">
                          <a:effectLst/>
                        </a:rPr>
                        <a:t>Day 7</a:t>
                      </a:r>
                      <a:endParaRPr lang="en-US" sz="2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400" b="1" kern="1200" dirty="0">
                          <a:effectLst/>
                        </a:rPr>
                        <a:t>Day 15</a:t>
                      </a:r>
                      <a:endParaRPr lang="en-US" sz="2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11511393"/>
                  </a:ext>
                </a:extLst>
              </a:tr>
              <a:tr h="4445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1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PRV wild-type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2303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2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257883111"/>
                  </a:ext>
                </a:extLst>
              </a:tr>
              <a:tr h="6223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2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2306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319571385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3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rowSpan="3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PRVtmv+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2309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0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0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849949992"/>
                  </a:ext>
                </a:extLst>
              </a:tr>
              <a:tr h="13208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4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2312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0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290519358"/>
                  </a:ext>
                </a:extLst>
              </a:tr>
              <a:tr h="2857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5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2315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0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6638532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249459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31776342"/>
              </p:ext>
            </p:extLst>
          </p:nvPr>
        </p:nvGraphicFramePr>
        <p:xfrm>
          <a:off x="651642" y="2127055"/>
          <a:ext cx="10878206" cy="3216786"/>
        </p:xfrm>
        <a:graphic>
          <a:graphicData uri="http://schemas.openxmlformats.org/drawingml/2006/table">
            <a:tbl>
              <a:tblPr firstRow="1" firstCol="1" bandRow="1">
                <a:tableStyleId>{93296810-A885-4BE3-A3E7-6D5BEEA58F35}</a:tableStyleId>
              </a:tblPr>
              <a:tblGrid>
                <a:gridCol w="1015989">
                  <a:extLst>
                    <a:ext uri="{9D8B030D-6E8A-4147-A177-3AD203B41FA5}">
                      <a16:colId xmlns:a16="http://schemas.microsoft.com/office/drawing/2014/main" val="1375020973"/>
                    </a:ext>
                  </a:extLst>
                </a:gridCol>
                <a:gridCol w="1453871">
                  <a:extLst>
                    <a:ext uri="{9D8B030D-6E8A-4147-A177-3AD203B41FA5}">
                      <a16:colId xmlns:a16="http://schemas.microsoft.com/office/drawing/2014/main" val="414966778"/>
                    </a:ext>
                  </a:extLst>
                </a:gridCol>
                <a:gridCol w="1484622">
                  <a:extLst>
                    <a:ext uri="{9D8B030D-6E8A-4147-A177-3AD203B41FA5}">
                      <a16:colId xmlns:a16="http://schemas.microsoft.com/office/drawing/2014/main" val="808382255"/>
                    </a:ext>
                  </a:extLst>
                </a:gridCol>
                <a:gridCol w="1041818">
                  <a:extLst>
                    <a:ext uri="{9D8B030D-6E8A-4147-A177-3AD203B41FA5}">
                      <a16:colId xmlns:a16="http://schemas.microsoft.com/office/drawing/2014/main" val="1033747988"/>
                    </a:ext>
                  </a:extLst>
                </a:gridCol>
                <a:gridCol w="1114388">
                  <a:extLst>
                    <a:ext uri="{9D8B030D-6E8A-4147-A177-3AD203B41FA5}">
                      <a16:colId xmlns:a16="http://schemas.microsoft.com/office/drawing/2014/main" val="470190741"/>
                    </a:ext>
                  </a:extLst>
                </a:gridCol>
                <a:gridCol w="1114388">
                  <a:extLst>
                    <a:ext uri="{9D8B030D-6E8A-4147-A177-3AD203B41FA5}">
                      <a16:colId xmlns:a16="http://schemas.microsoft.com/office/drawing/2014/main" val="3328326551"/>
                    </a:ext>
                  </a:extLst>
                </a:gridCol>
                <a:gridCol w="1217710">
                  <a:extLst>
                    <a:ext uri="{9D8B030D-6E8A-4147-A177-3AD203B41FA5}">
                      <a16:colId xmlns:a16="http://schemas.microsoft.com/office/drawing/2014/main" val="1166284"/>
                    </a:ext>
                  </a:extLst>
                </a:gridCol>
                <a:gridCol w="1217710">
                  <a:extLst>
                    <a:ext uri="{9D8B030D-6E8A-4147-A177-3AD203B41FA5}">
                      <a16:colId xmlns:a16="http://schemas.microsoft.com/office/drawing/2014/main" val="166130216"/>
                    </a:ext>
                  </a:extLst>
                </a:gridCol>
                <a:gridCol w="1217710">
                  <a:extLst>
                    <a:ext uri="{9D8B030D-6E8A-4147-A177-3AD203B41FA5}">
                      <a16:colId xmlns:a16="http://schemas.microsoft.com/office/drawing/2014/main" val="532834653"/>
                    </a:ext>
                  </a:extLst>
                </a:gridCol>
              </a:tblGrid>
              <a:tr h="423545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S no.: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 </a:t>
                      </a:r>
                      <a:endParaRPr lang="en-US" sz="2400">
                        <a:effectLst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Group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 </a:t>
                      </a:r>
                      <a:endParaRPr lang="en-US" sz="2400" dirty="0">
                        <a:effectLst/>
                      </a:endParaRPr>
                    </a:p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Animal #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gridSpan="6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PRV genome copies (per 100 ng of DNA)</a:t>
                      </a:r>
                      <a:endParaRPr lang="en-US" sz="2400" dirty="0">
                        <a:effectLst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Days-post dexamethasone injection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57437919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Day 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Day 1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Day 2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Day 3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Day 4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Day 5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11511393"/>
                  </a:ext>
                </a:extLst>
              </a:tr>
              <a:tr h="4445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1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PRV wild type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2303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1276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4257883111"/>
                  </a:ext>
                </a:extLst>
              </a:tr>
              <a:tr h="6223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2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2306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0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0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0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293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2173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19571385"/>
                  </a:ext>
                </a:extLst>
              </a:tr>
              <a:tr h="17780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3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rowSpan="3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 </a:t>
                      </a:r>
                      <a:endParaRPr lang="en-US" sz="2400">
                        <a:effectLst/>
                      </a:endParaRP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PRVtmv+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2309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0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849949992"/>
                  </a:ext>
                </a:extLst>
              </a:tr>
              <a:tr h="13208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4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2312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290519358"/>
                  </a:ext>
                </a:extLst>
              </a:tr>
              <a:tr h="28575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5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2315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0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66385326"/>
                  </a:ext>
                </a:extLst>
              </a:tr>
            </a:tbl>
          </a:graphicData>
        </a:graphic>
      </p:graphicFrame>
      <p:sp>
        <p:nvSpPr>
          <p:cNvPr id="3" name="Rectangle 2"/>
          <p:cNvSpPr/>
          <p:nvPr/>
        </p:nvSpPr>
        <p:spPr>
          <a:xfrm>
            <a:off x="651642" y="1294646"/>
            <a:ext cx="1078361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b="1" dirty="0"/>
              <a:t>Supplementary Table S3.</a:t>
            </a:r>
            <a:r>
              <a:rPr lang="en-US" sz="2400" dirty="0"/>
              <a:t> Nasal shedding following latency reactivation determined by PRV-specific qPCR </a:t>
            </a:r>
          </a:p>
        </p:txBody>
      </p:sp>
    </p:spTree>
    <p:extLst>
      <p:ext uri="{BB962C8B-B14F-4D97-AF65-F5344CB8AC3E}">
        <p14:creationId xmlns:p14="http://schemas.microsoft.com/office/powerpoint/2010/main" val="31586338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A7EBCF56-0814-D619-57CA-5C8DB9F8099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2707140"/>
              </p:ext>
            </p:extLst>
          </p:nvPr>
        </p:nvGraphicFramePr>
        <p:xfrm>
          <a:off x="947957" y="1266738"/>
          <a:ext cx="9731228" cy="519002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76021">
                  <a:extLst>
                    <a:ext uri="{9D8B030D-6E8A-4147-A177-3AD203B41FA5}">
                      <a16:colId xmlns:a16="http://schemas.microsoft.com/office/drawing/2014/main" val="212831365"/>
                    </a:ext>
                  </a:extLst>
                </a:gridCol>
                <a:gridCol w="2132001">
                  <a:extLst>
                    <a:ext uri="{9D8B030D-6E8A-4147-A177-3AD203B41FA5}">
                      <a16:colId xmlns:a16="http://schemas.microsoft.com/office/drawing/2014/main" val="701719665"/>
                    </a:ext>
                  </a:extLst>
                </a:gridCol>
                <a:gridCol w="1139883">
                  <a:extLst>
                    <a:ext uri="{9D8B030D-6E8A-4147-A177-3AD203B41FA5}">
                      <a16:colId xmlns:a16="http://schemas.microsoft.com/office/drawing/2014/main" val="328230380"/>
                    </a:ext>
                  </a:extLst>
                </a:gridCol>
                <a:gridCol w="5583323">
                  <a:extLst>
                    <a:ext uri="{9D8B030D-6E8A-4147-A177-3AD203B41FA5}">
                      <a16:colId xmlns:a16="http://schemas.microsoft.com/office/drawing/2014/main" val="1780755598"/>
                    </a:ext>
                  </a:extLst>
                </a:gridCol>
              </a:tblGrid>
              <a:tr h="81944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S no.: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Group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Animal #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PRV genome copies in trigeminal ganglion (TG)</a:t>
                      </a:r>
                      <a:r>
                        <a:rPr lang="en-US" sz="2400" kern="1200" baseline="0" dirty="0">
                          <a:effectLst/>
                        </a:rPr>
                        <a:t> </a:t>
                      </a:r>
                      <a:r>
                        <a:rPr lang="en-US" sz="2400" kern="1200" dirty="0">
                          <a:effectLst/>
                        </a:rPr>
                        <a:t>samples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591315161"/>
                  </a:ext>
                </a:extLst>
              </a:tr>
              <a:tr h="3973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TG DNA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916183125"/>
                  </a:ext>
                </a:extLst>
              </a:tr>
              <a:tr h="3973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1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Mock infected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2314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064266448"/>
                  </a:ext>
                </a:extLst>
              </a:tr>
              <a:tr h="3973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2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2311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963629727"/>
                  </a:ext>
                </a:extLst>
              </a:tr>
              <a:tr h="3973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3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rowSpan="3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PRVtmv+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latency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2302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1133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097618365"/>
                  </a:ext>
                </a:extLst>
              </a:tr>
              <a:tr h="3973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4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2317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1647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311475577"/>
                  </a:ext>
                </a:extLst>
              </a:tr>
              <a:tr h="3973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5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2313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2151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46253246"/>
                  </a:ext>
                </a:extLst>
              </a:tr>
              <a:tr h="3973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6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PRV wildtype latency – Dex+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400" kern="1200" dirty="0">
                          <a:effectLst/>
                        </a:rPr>
                        <a:t>2303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190,123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827976149"/>
                  </a:ext>
                </a:extLst>
              </a:tr>
              <a:tr h="3973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7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dirty="0"/>
                        <a:t>2306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55,725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230660593"/>
                  </a:ext>
                </a:extLst>
              </a:tr>
              <a:tr h="3973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8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row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PRVtmv+</a:t>
                      </a:r>
                      <a:r>
                        <a:rPr lang="en-US" sz="2400" kern="12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 - Dex+</a:t>
                      </a:r>
                      <a:endParaRPr lang="en-US" sz="2400" dirty="0">
                        <a:effectLst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2309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159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25112602"/>
                  </a:ext>
                </a:extLst>
              </a:tr>
              <a:tr h="3973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9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2312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1588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569307446"/>
                  </a:ext>
                </a:extLst>
              </a:tr>
              <a:tr h="3973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1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2315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1776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72848885"/>
                  </a:ext>
                </a:extLst>
              </a:tr>
            </a:tbl>
          </a:graphicData>
        </a:graphic>
      </p:graphicFrame>
      <p:sp>
        <p:nvSpPr>
          <p:cNvPr id="8" name="Rectangle 7">
            <a:extLst>
              <a:ext uri="{FF2B5EF4-FFF2-40B4-BE49-F238E27FC236}">
                <a16:creationId xmlns:a16="http://schemas.microsoft.com/office/drawing/2014/main" id="{6E2EBC3C-A534-D5A3-784E-50D564ACD268}"/>
              </a:ext>
            </a:extLst>
          </p:cNvPr>
          <p:cNvSpPr/>
          <p:nvPr/>
        </p:nvSpPr>
        <p:spPr>
          <a:xfrm>
            <a:off x="651642" y="480913"/>
            <a:ext cx="1078361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b="1" dirty="0"/>
              <a:t>Supplementary Table S4.</a:t>
            </a:r>
            <a:r>
              <a:rPr lang="en-US" sz="2400" dirty="0"/>
              <a:t> Quantifying targeted PRV genome copies in the trigeminal ganglion (TG) of infected/immunized pigs</a:t>
            </a:r>
          </a:p>
        </p:txBody>
      </p:sp>
    </p:spTree>
    <p:extLst>
      <p:ext uri="{BB962C8B-B14F-4D97-AF65-F5344CB8AC3E}">
        <p14:creationId xmlns:p14="http://schemas.microsoft.com/office/powerpoint/2010/main" val="4319933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E58E17BA-3B21-7F1C-0C3B-AB05112631D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19765003"/>
              </p:ext>
            </p:extLst>
          </p:nvPr>
        </p:nvGraphicFramePr>
        <p:xfrm>
          <a:off x="947957" y="1266738"/>
          <a:ext cx="9731228" cy="519002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76021">
                  <a:extLst>
                    <a:ext uri="{9D8B030D-6E8A-4147-A177-3AD203B41FA5}">
                      <a16:colId xmlns:a16="http://schemas.microsoft.com/office/drawing/2014/main" val="212831365"/>
                    </a:ext>
                  </a:extLst>
                </a:gridCol>
                <a:gridCol w="2132001">
                  <a:extLst>
                    <a:ext uri="{9D8B030D-6E8A-4147-A177-3AD203B41FA5}">
                      <a16:colId xmlns:a16="http://schemas.microsoft.com/office/drawing/2014/main" val="701719665"/>
                    </a:ext>
                  </a:extLst>
                </a:gridCol>
                <a:gridCol w="1139883">
                  <a:extLst>
                    <a:ext uri="{9D8B030D-6E8A-4147-A177-3AD203B41FA5}">
                      <a16:colId xmlns:a16="http://schemas.microsoft.com/office/drawing/2014/main" val="328230380"/>
                    </a:ext>
                  </a:extLst>
                </a:gridCol>
                <a:gridCol w="1861108">
                  <a:extLst>
                    <a:ext uri="{9D8B030D-6E8A-4147-A177-3AD203B41FA5}">
                      <a16:colId xmlns:a16="http://schemas.microsoft.com/office/drawing/2014/main" val="1780755598"/>
                    </a:ext>
                  </a:extLst>
                </a:gridCol>
                <a:gridCol w="1861107">
                  <a:extLst>
                    <a:ext uri="{9D8B030D-6E8A-4147-A177-3AD203B41FA5}">
                      <a16:colId xmlns:a16="http://schemas.microsoft.com/office/drawing/2014/main" val="910140930"/>
                    </a:ext>
                  </a:extLst>
                </a:gridCol>
                <a:gridCol w="1861108">
                  <a:extLst>
                    <a:ext uri="{9D8B030D-6E8A-4147-A177-3AD203B41FA5}">
                      <a16:colId xmlns:a16="http://schemas.microsoft.com/office/drawing/2014/main" val="3894642489"/>
                    </a:ext>
                  </a:extLst>
                </a:gridCol>
              </a:tblGrid>
              <a:tr h="819440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S no.: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Group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Animal #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gridSpan="3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PRV transcript copies in trigeminal ganglion (TG)</a:t>
                      </a:r>
                      <a:r>
                        <a:rPr lang="en-US" sz="2400" kern="1200" baseline="0" dirty="0">
                          <a:effectLst/>
                        </a:rPr>
                        <a:t> </a:t>
                      </a:r>
                      <a:r>
                        <a:rPr lang="en-US" sz="2400" kern="1200" dirty="0">
                          <a:effectLst/>
                        </a:rPr>
                        <a:t>samples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591315161"/>
                  </a:ext>
                </a:extLst>
              </a:tr>
              <a:tr h="39732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 kern="1200" dirty="0">
                          <a:effectLst/>
                        </a:rPr>
                        <a:t>ICP0</a:t>
                      </a:r>
                      <a:endParaRPr lang="en-US" sz="2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CP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gC</a:t>
                      </a:r>
                      <a:endParaRPr lang="en-US" sz="2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916183125"/>
                  </a:ext>
                </a:extLst>
              </a:tr>
              <a:tr h="3973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1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Mock infected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2314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064266448"/>
                  </a:ext>
                </a:extLst>
              </a:tr>
              <a:tr h="3973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2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2311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963629727"/>
                  </a:ext>
                </a:extLst>
              </a:tr>
              <a:tr h="3973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3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rowSpan="3"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PRVtmv+</a:t>
                      </a:r>
                    </a:p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latency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2302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0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4097618365"/>
                  </a:ext>
                </a:extLst>
              </a:tr>
              <a:tr h="3973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4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2317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0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311475577"/>
                  </a:ext>
                </a:extLst>
              </a:tr>
              <a:tr h="3973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5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2313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646253246"/>
                  </a:ext>
                </a:extLst>
              </a:tr>
              <a:tr h="3973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6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PRV wild-type latency – Dex+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400" kern="1200" dirty="0">
                          <a:effectLst/>
                        </a:rPr>
                        <a:t>2303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455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41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87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827976149"/>
                  </a:ext>
                </a:extLst>
              </a:tr>
              <a:tr h="3973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7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400" dirty="0"/>
                        <a:t>2306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1966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01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386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230660593"/>
                  </a:ext>
                </a:extLst>
              </a:tr>
              <a:tr h="3973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8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row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PRVtmv+</a:t>
                      </a:r>
                      <a:r>
                        <a:rPr lang="en-US" sz="2400" kern="1200" dirty="0">
                          <a:effectLst/>
                          <a:latin typeface="Calibri" panose="020F0502020204030204" pitchFamily="34" charset="0"/>
                          <a:cs typeface="Times New Roman" panose="02020603050405020304" pitchFamily="18" charset="0"/>
                        </a:rPr>
                        <a:t> - Dex+</a:t>
                      </a:r>
                      <a:endParaRPr lang="en-US" sz="2400" dirty="0">
                        <a:effectLst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2309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64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25112602"/>
                  </a:ext>
                </a:extLst>
              </a:tr>
              <a:tr h="3973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9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2312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137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2569307446"/>
                  </a:ext>
                </a:extLst>
              </a:tr>
              <a:tr h="397326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>
                          <a:effectLst/>
                        </a:rPr>
                        <a:t>10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</a:rPr>
                        <a:t>2315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kern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8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6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672848885"/>
                  </a:ext>
                </a:extLst>
              </a:tr>
            </a:tbl>
          </a:graphicData>
        </a:graphic>
      </p:graphicFrame>
      <p:sp>
        <p:nvSpPr>
          <p:cNvPr id="8" name="Rectangle 7">
            <a:extLst>
              <a:ext uri="{FF2B5EF4-FFF2-40B4-BE49-F238E27FC236}">
                <a16:creationId xmlns:a16="http://schemas.microsoft.com/office/drawing/2014/main" id="{AF9B3109-3B30-F081-2DD8-971D86E83382}"/>
              </a:ext>
            </a:extLst>
          </p:cNvPr>
          <p:cNvSpPr/>
          <p:nvPr/>
        </p:nvSpPr>
        <p:spPr>
          <a:xfrm>
            <a:off x="651642" y="480913"/>
            <a:ext cx="10783613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b="1" dirty="0"/>
              <a:t>Supplementary Table S5.</a:t>
            </a:r>
            <a:r>
              <a:rPr lang="en-US" sz="2400" dirty="0"/>
              <a:t> Quantifying targeted PRV transcript copies in the trigeminal ganglion (TG) of infected/immunized pigs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349870580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8DBADD35-E5F9-4B4E-A45A-E71180C515F0}"/>
              </a:ext>
            </a:extLst>
          </p:cNvPr>
          <p:cNvGraphicFramePr>
            <a:graphicFrameLocks noGrp="1"/>
          </p:cNvGraphicFramePr>
          <p:nvPr/>
        </p:nvGraphicFramePr>
        <p:xfrm>
          <a:off x="609597" y="1748094"/>
          <a:ext cx="10762595" cy="3859086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845909">
                  <a:extLst>
                    <a:ext uri="{9D8B030D-6E8A-4147-A177-3AD203B41FA5}">
                      <a16:colId xmlns:a16="http://schemas.microsoft.com/office/drawing/2014/main" val="1017250103"/>
                    </a:ext>
                  </a:extLst>
                </a:gridCol>
                <a:gridCol w="843878">
                  <a:extLst>
                    <a:ext uri="{9D8B030D-6E8A-4147-A177-3AD203B41FA5}">
                      <a16:colId xmlns:a16="http://schemas.microsoft.com/office/drawing/2014/main" val="1658764320"/>
                    </a:ext>
                  </a:extLst>
                </a:gridCol>
                <a:gridCol w="1345468">
                  <a:extLst>
                    <a:ext uri="{9D8B030D-6E8A-4147-A177-3AD203B41FA5}">
                      <a16:colId xmlns:a16="http://schemas.microsoft.com/office/drawing/2014/main" val="571429367"/>
                    </a:ext>
                  </a:extLst>
                </a:gridCol>
                <a:gridCol w="1345468">
                  <a:extLst>
                    <a:ext uri="{9D8B030D-6E8A-4147-A177-3AD203B41FA5}">
                      <a16:colId xmlns:a16="http://schemas.microsoft.com/office/drawing/2014/main" val="884653356"/>
                    </a:ext>
                  </a:extLst>
                </a:gridCol>
                <a:gridCol w="1345468">
                  <a:extLst>
                    <a:ext uri="{9D8B030D-6E8A-4147-A177-3AD203B41FA5}">
                      <a16:colId xmlns:a16="http://schemas.microsoft.com/office/drawing/2014/main" val="127427426"/>
                    </a:ext>
                  </a:extLst>
                </a:gridCol>
                <a:gridCol w="1345468">
                  <a:extLst>
                    <a:ext uri="{9D8B030D-6E8A-4147-A177-3AD203B41FA5}">
                      <a16:colId xmlns:a16="http://schemas.microsoft.com/office/drawing/2014/main" val="638814126"/>
                    </a:ext>
                  </a:extLst>
                </a:gridCol>
                <a:gridCol w="1345468">
                  <a:extLst>
                    <a:ext uri="{9D8B030D-6E8A-4147-A177-3AD203B41FA5}">
                      <a16:colId xmlns:a16="http://schemas.microsoft.com/office/drawing/2014/main" val="3512453248"/>
                    </a:ext>
                  </a:extLst>
                </a:gridCol>
                <a:gridCol w="1345468">
                  <a:extLst>
                    <a:ext uri="{9D8B030D-6E8A-4147-A177-3AD203B41FA5}">
                      <a16:colId xmlns:a16="http://schemas.microsoft.com/office/drawing/2014/main" val="298959763"/>
                    </a:ext>
                  </a:extLst>
                </a:gridCol>
              </a:tblGrid>
              <a:tr h="472097">
                <a:tc rowSpan="2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Group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gridSpan="7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PRV neutralizing antibody titer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19043323"/>
                  </a:ext>
                </a:extLst>
              </a:tr>
              <a:tr h="47209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 dirty="0">
                          <a:effectLst/>
                        </a:rPr>
                        <a:t>Pig #</a:t>
                      </a:r>
                      <a:endParaRPr lang="en-US" sz="2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 dirty="0">
                          <a:effectLst/>
                        </a:rPr>
                        <a:t>Day 0</a:t>
                      </a:r>
                      <a:endParaRPr lang="en-US" sz="2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 dirty="0">
                          <a:effectLst/>
                        </a:rPr>
                        <a:t>Day 7</a:t>
                      </a:r>
                      <a:endParaRPr lang="en-US" sz="2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 dirty="0">
                          <a:effectLst/>
                        </a:rPr>
                        <a:t>Day 15</a:t>
                      </a:r>
                      <a:endParaRPr lang="en-US" sz="2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>
                          <a:effectLst/>
                        </a:rPr>
                        <a:t>Day 21</a:t>
                      </a:r>
                      <a:endParaRPr lang="en-US" sz="24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>
                          <a:effectLst/>
                        </a:rPr>
                        <a:t>Day 28</a:t>
                      </a:r>
                      <a:endParaRPr lang="en-US" sz="2400" b="1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 dirty="0">
                          <a:effectLst/>
                        </a:rPr>
                        <a:t>Day 33</a:t>
                      </a:r>
                      <a:endParaRPr lang="en-US" sz="2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969071639"/>
                  </a:ext>
                </a:extLst>
              </a:tr>
              <a:tr h="472097">
                <a:tc rowSpan="3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PRV </a:t>
                      </a: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wild-type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2303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˂4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68.14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120.09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218.51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124.4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1206.97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84463245"/>
                  </a:ext>
                </a:extLst>
              </a:tr>
              <a:tr h="236049">
                <a:tc vMerge="1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2306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˂4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77.35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184.54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253.18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117.52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985.81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2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3437497"/>
                  </a:ext>
                </a:extLst>
              </a:tr>
              <a:tr h="23604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ve.</a:t>
                      </a:r>
                    </a:p>
                  </a:txBody>
                  <a:tcPr marL="68580" marR="68580" marT="0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400" b="1" dirty="0">
                          <a:effectLst/>
                        </a:rPr>
                        <a:t>˂4</a:t>
                      </a:r>
                      <a:endParaRPr lang="en-US" sz="2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2.745</a:t>
                      </a:r>
                    </a:p>
                  </a:txBody>
                  <a:tcPr marL="9525" marR="9525" marT="9525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2.315</a:t>
                      </a:r>
                    </a:p>
                  </a:txBody>
                  <a:tcPr marL="9525" marR="9525" marT="9525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35.845</a:t>
                      </a:r>
                    </a:p>
                  </a:txBody>
                  <a:tcPr marL="9525" marR="9525" marT="9525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0.96</a:t>
                      </a:r>
                    </a:p>
                  </a:txBody>
                  <a:tcPr marL="9525" marR="9525" marT="9525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96.39</a:t>
                      </a:r>
                    </a:p>
                  </a:txBody>
                  <a:tcPr marL="9525" marR="9525" marT="9525" marB="0" anchor="b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1856304"/>
                  </a:ext>
                </a:extLst>
              </a:tr>
              <a:tr h="472097">
                <a:tc rowSpan="4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PRVtmv+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2309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˂4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5.74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27.27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32.57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15.98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13.42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48168334"/>
                  </a:ext>
                </a:extLst>
              </a:tr>
              <a:tr h="47209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>
                          <a:effectLst/>
                        </a:rPr>
                        <a:t>2312</a:t>
                      </a:r>
                      <a:endParaRPr lang="en-US" sz="24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˂4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21.36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92.97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56.51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14.23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11.33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66804845"/>
                  </a:ext>
                </a:extLst>
              </a:tr>
              <a:tr h="23604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2315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˂4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12.57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30.81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33.03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15.01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dirty="0">
                          <a:effectLst/>
                        </a:rPr>
                        <a:t>10.57</a:t>
                      </a:r>
                      <a:endParaRPr lang="en-US" sz="24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6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86742918"/>
                  </a:ext>
                </a:extLst>
              </a:tr>
              <a:tr h="23604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24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Ave.</a:t>
                      </a:r>
                    </a:p>
                  </a:txBody>
                  <a:tcPr marL="68580" marR="68580" marT="0" marB="0" anchor="ctr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400" b="1" dirty="0">
                          <a:effectLst/>
                        </a:rPr>
                        <a:t>˂4</a:t>
                      </a:r>
                      <a:endParaRPr lang="en-US" sz="24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22</a:t>
                      </a:r>
                    </a:p>
                  </a:txBody>
                  <a:tcPr marL="9525" marR="9525" marT="9525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0.35</a:t>
                      </a:r>
                    </a:p>
                  </a:txBody>
                  <a:tcPr marL="9525" marR="9525" marT="9525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0.70</a:t>
                      </a:r>
                    </a:p>
                  </a:txBody>
                  <a:tcPr marL="9525" marR="9525" marT="9525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.07</a:t>
                      </a:r>
                    </a:p>
                  </a:txBody>
                  <a:tcPr marL="9525" marR="9525" marT="9525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24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77</a:t>
                      </a:r>
                    </a:p>
                  </a:txBody>
                  <a:tcPr marL="9525" marR="9525" marT="9525" marB="0" anchor="b">
                    <a:solidFill>
                      <a:schemeClr val="accent6">
                        <a:lumMod val="40000"/>
                        <a:lumOff val="6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1946094"/>
                  </a:ext>
                </a:extLst>
              </a:tr>
            </a:tbl>
          </a:graphicData>
        </a:graphic>
      </p:graphicFrame>
      <p:sp>
        <p:nvSpPr>
          <p:cNvPr id="3" name="Rectangle 2">
            <a:extLst>
              <a:ext uri="{FF2B5EF4-FFF2-40B4-BE49-F238E27FC236}">
                <a16:creationId xmlns:a16="http://schemas.microsoft.com/office/drawing/2014/main" id="{8D2419D2-41F6-4D9B-8B9B-B1DA11EA27D1}"/>
              </a:ext>
            </a:extLst>
          </p:cNvPr>
          <p:cNvSpPr/>
          <p:nvPr/>
        </p:nvSpPr>
        <p:spPr>
          <a:xfrm>
            <a:off x="630717" y="906733"/>
            <a:ext cx="11029979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b="1" dirty="0"/>
              <a:t>Supplementary </a:t>
            </a:r>
            <a:r>
              <a:rPr lang="en-US" sz="2400" b="1"/>
              <a:t>Table S6</a:t>
            </a:r>
            <a:r>
              <a:rPr lang="en-US" sz="2400" b="1" dirty="0"/>
              <a:t>.</a:t>
            </a:r>
            <a:r>
              <a:rPr lang="en-US" sz="2400"/>
              <a:t> </a:t>
            </a:r>
            <a:r>
              <a:rPr lang="en-US" sz="2400" dirty="0"/>
              <a:t>PRV-specific serum neutralizing (SN) antibody titer developed in pigs following infection and Dexamethasone-induced latency-reactivation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41EAD48-C3D8-FDEE-9C0F-0EB07153C08F}"/>
              </a:ext>
            </a:extLst>
          </p:cNvPr>
          <p:cNvSpPr txBox="1"/>
          <p:nvPr/>
        </p:nvSpPr>
        <p:spPr>
          <a:xfrm>
            <a:off x="2835479" y="5947794"/>
            <a:ext cx="15855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ve. - Average</a:t>
            </a:r>
          </a:p>
        </p:txBody>
      </p:sp>
    </p:spTree>
    <p:extLst>
      <p:ext uri="{BB962C8B-B14F-4D97-AF65-F5344CB8AC3E}">
        <p14:creationId xmlns:p14="http://schemas.microsoft.com/office/powerpoint/2010/main" val="1252022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610</TotalTime>
  <Words>600</Words>
  <Application>Microsoft Office PowerPoint</Application>
  <PresentationFormat>Widescreen</PresentationFormat>
  <Paragraphs>378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vulraj Selvaraj</dc:creator>
  <cp:lastModifiedBy>MDPI</cp:lastModifiedBy>
  <cp:revision>30</cp:revision>
  <dcterms:created xsi:type="dcterms:W3CDTF">2022-01-27T05:34:57Z</dcterms:created>
  <dcterms:modified xsi:type="dcterms:W3CDTF">2023-02-08T13:10:38Z</dcterms:modified>
</cp:coreProperties>
</file>